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4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8000"/>
    <a:srgbClr val="FF00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59" d="100"/>
          <a:sy n="59" d="100"/>
        </p:scale>
        <p:origin x="1098" y="60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5AD636-6140-4181-898D-98C458BE7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143873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A5F2AE-7291-4DFC-B19E-0928D9A429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196194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7258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573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366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1873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383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427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111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858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1656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585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112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021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0" y="0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altLang="ja-JP" sz="14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S10</a:t>
            </a:r>
            <a:endParaRPr kumimoji="1" lang="ja-JP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582671" y="1957892"/>
            <a:ext cx="1369286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S1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terminus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S1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terminus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ME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TAT3</a:t>
            </a: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T3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K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K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K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6" name="グループ化 45"/>
          <p:cNvGrpSpPr/>
          <p:nvPr/>
        </p:nvGrpSpPr>
        <p:grpSpPr>
          <a:xfrm>
            <a:off x="4993662" y="1338140"/>
            <a:ext cx="1519773" cy="805645"/>
            <a:chOff x="1174045" y="646726"/>
            <a:chExt cx="1519773" cy="805645"/>
          </a:xfrm>
        </p:grpSpPr>
        <p:sp>
          <p:nvSpPr>
            <p:cNvPr id="47" name="テキスト ボックス 46"/>
            <p:cNvSpPr txBox="1"/>
            <p:nvPr/>
          </p:nvSpPr>
          <p:spPr>
            <a:xfrm>
              <a:off x="1667026" y="646726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CC78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1174045" y="1175372"/>
              <a:ext cx="1492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10   100  10   100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1255757" y="938090"/>
              <a:ext cx="811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zo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1933674" y="938090"/>
              <a:ext cx="7601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ec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2" name="直線コネクタ 51"/>
            <p:cNvCxnSpPr/>
            <p:nvPr/>
          </p:nvCxnSpPr>
          <p:spPr>
            <a:xfrm>
              <a:off x="1482290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/>
            <p:cNvCxnSpPr/>
            <p:nvPr/>
          </p:nvCxnSpPr>
          <p:spPr>
            <a:xfrm>
              <a:off x="2058202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5" name="図 5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8" t="65234" r="65410" b="32084"/>
          <a:stretch/>
        </p:blipFill>
        <p:spPr>
          <a:xfrm>
            <a:off x="4952654" y="4854675"/>
            <a:ext cx="1479319" cy="1277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図 5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1" t="60145" r="65513" b="37129"/>
          <a:stretch/>
        </p:blipFill>
        <p:spPr>
          <a:xfrm>
            <a:off x="4969181" y="4052509"/>
            <a:ext cx="1452402" cy="1298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図 5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6" t="63614" r="65382" b="33263"/>
          <a:stretch/>
        </p:blipFill>
        <p:spPr>
          <a:xfrm>
            <a:off x="4935096" y="4579137"/>
            <a:ext cx="1491681" cy="1487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図 57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8" t="54362" r="65390" b="42375"/>
          <a:stretch/>
        </p:blipFill>
        <p:spPr>
          <a:xfrm>
            <a:off x="4936129" y="4312667"/>
            <a:ext cx="1480257" cy="1554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図 58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0" t="60145" r="65500" b="36944"/>
          <a:stretch/>
        </p:blipFill>
        <p:spPr>
          <a:xfrm>
            <a:off x="4968554" y="3482616"/>
            <a:ext cx="1453028" cy="1386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0" name="図 59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9" t="38632" r="65384" b="57538"/>
          <a:stretch/>
        </p:blipFill>
        <p:spPr>
          <a:xfrm>
            <a:off x="4941637" y="3740135"/>
            <a:ext cx="1469554" cy="1737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図 60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9" t="43721" r="65436" b="52776"/>
          <a:stretch/>
        </p:blipFill>
        <p:spPr>
          <a:xfrm>
            <a:off x="4959656" y="2898492"/>
            <a:ext cx="1467122" cy="1668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図 61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0" t="48800" r="65321" b="48116"/>
          <a:stretch/>
        </p:blipFill>
        <p:spPr>
          <a:xfrm>
            <a:off x="4957015" y="3204210"/>
            <a:ext cx="1480153" cy="1468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図 62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" t="41800" r="65212" b="54152"/>
          <a:stretch/>
        </p:blipFill>
        <p:spPr>
          <a:xfrm>
            <a:off x="4947490" y="2623184"/>
            <a:ext cx="1494874" cy="1927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4" name="図 63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7" t="47538" r="65329" b="49080"/>
          <a:stretch/>
        </p:blipFill>
        <p:spPr>
          <a:xfrm>
            <a:off x="4966854" y="2353541"/>
            <a:ext cx="1465119" cy="1610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図 64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0" t="47401" r="65211" b="48988"/>
          <a:stretch/>
        </p:blipFill>
        <p:spPr>
          <a:xfrm>
            <a:off x="4966540" y="2108836"/>
            <a:ext cx="1475824" cy="17197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0034854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9</TotalTime>
  <Words>24</Words>
  <Application>Microsoft Office PowerPoint</Application>
  <PresentationFormat>ワイド画面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rugaki,Ko 古垣耕(プロダクトＲ部Ｏ育薬研究１Ｇ)</dc:creator>
  <cp:lastModifiedBy>Furugaki,Ko 古垣耕(プロダクトＲ部Ｏ育薬研究１Ｇ)</cp:lastModifiedBy>
  <cp:revision>195</cp:revision>
  <cp:lastPrinted>2017-03-13T01:57:05Z</cp:lastPrinted>
  <dcterms:created xsi:type="dcterms:W3CDTF">2016-11-14T09:26:54Z</dcterms:created>
  <dcterms:modified xsi:type="dcterms:W3CDTF">2017-09-22T13:55:32Z</dcterms:modified>
</cp:coreProperties>
</file>